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42DA04-D894-4066-89C8-8AD2215BBE5D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FA53EA-0467-4CC2-B079-335EE859D85C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2"/>
          <p:cNvSpPr/>
          <p:nvPr/>
        </p:nvSpPr>
        <p:spPr>
          <a:xfrm>
            <a:off x="3882960" y="8685360"/>
            <a:ext cx="2962440" cy="44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38501C05-BEC2-490C-9B06-E94707348BA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"/>
          <p:cNvSpPr/>
          <p:nvPr/>
        </p:nvSpPr>
        <p:spPr>
          <a:xfrm>
            <a:off x="1143000" y="685800"/>
            <a:ext cx="457056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1"/>
          <p:cNvSpPr>
            <a:spLocks noGrp="1"/>
          </p:cNvSpPr>
          <p:nvPr>
            <p:ph type="body"/>
          </p:nvPr>
        </p:nvSpPr>
        <p:spPr>
          <a:xfrm>
            <a:off x="685440" y="4343040"/>
            <a:ext cx="5481720" cy="4205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3969E-A2A6-4664-8AD5-E03CEDA5C3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0E0F4-84F3-485C-BD61-FD2ADCB706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B7373-84C2-4822-85CD-CF307BC141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9719D-2070-4678-A359-0362C45470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83830-D6E6-4E8C-ACC4-FCBD4ABC30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C4F6B-8407-48A0-8289-4CF1F36E67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E4561-8AA1-4740-BBE3-1376A7D73C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B4D00-C363-4F8B-B53B-E97ADD4065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C3122-197F-444A-A656-C84919AB70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EA96C-3601-41E4-BADB-C32105D19C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CE4C7-4FE6-418C-B289-2834861BCB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D8C9C-62AD-4151-AD99-8CE2B2C0B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C9D0CB-D1C9-4878-BA53-1E28C06816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"/>
          <p:cNvSpPr/>
          <p:nvPr/>
        </p:nvSpPr>
        <p:spPr>
          <a:xfrm>
            <a:off x="684360" y="5654520"/>
            <a:ext cx="82803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2. Analysis of variant Ia component of iota toxin that is putatively produced by strain PB-1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Upper portion shows putative functional regions. Lower portion shows comparison of deduced amino acid sequence of the iota toxin Ia component encoded by pCPPB-1,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. perfringens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type E strain (JGS1987), or the activity component of CdtA toxin in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. difficil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684360" y="1695600"/>
            <a:ext cx="6121080" cy="39654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0" name=""/>
          <p:cNvGraphicFramePr/>
          <p:nvPr/>
        </p:nvGraphicFramePr>
        <p:xfrm>
          <a:off x="684360" y="333360"/>
          <a:ext cx="7181640" cy="122868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684360" y="333360"/>
                    <a:ext cx="7181640" cy="1228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2:30Z</dcterms:modified>
  <cp:revision>2</cp:revision>
  <dc:subject/>
  <dc:title>スライド 1</dc:title>
</cp:coreProperties>
</file>